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0" r:id="rId2"/>
    <p:sldId id="259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48" userDrawn="1">
          <p15:clr>
            <a:srgbClr val="A4A3A4"/>
          </p15:clr>
        </p15:guide>
        <p15:guide id="2" pos="618" userDrawn="1">
          <p15:clr>
            <a:srgbClr val="A4A3A4"/>
          </p15:clr>
        </p15:guide>
        <p15:guide id="3" orient="horz" pos="2313" userDrawn="1">
          <p15:clr>
            <a:srgbClr val="A4A3A4"/>
          </p15:clr>
        </p15:guide>
        <p15:guide id="4" pos="2976" userDrawn="1">
          <p15:clr>
            <a:srgbClr val="A4A3A4"/>
          </p15:clr>
        </p15:guide>
        <p15:guide id="5" orient="horz" pos="5103" userDrawn="1">
          <p15:clr>
            <a:srgbClr val="A4A3A4"/>
          </p15:clr>
        </p15:guide>
        <p15:guide id="7" orient="horz" pos="3447" userDrawn="1">
          <p15:clr>
            <a:srgbClr val="A4A3A4"/>
          </p15:clr>
        </p15:guide>
        <p15:guide id="8" orient="horz" pos="3696" userDrawn="1">
          <p15:clr>
            <a:srgbClr val="A4A3A4"/>
          </p15:clr>
        </p15:guide>
        <p15:guide id="9" orient="horz" pos="4344" userDrawn="1">
          <p15:clr>
            <a:srgbClr val="A4A3A4"/>
          </p15:clr>
        </p15:guide>
        <p15:guide id="11" pos="4320" userDrawn="1">
          <p15:clr>
            <a:srgbClr val="A4A3A4"/>
          </p15:clr>
        </p15:guide>
        <p15:guide id="13" orient="horz" pos="1383" userDrawn="1">
          <p15:clr>
            <a:srgbClr val="A4A3A4"/>
          </p15:clr>
        </p15:guide>
        <p15:guide id="14" orient="horz" pos="744" userDrawn="1">
          <p15:clr>
            <a:srgbClr val="A4A3A4"/>
          </p15:clr>
        </p15:guide>
        <p15:guide id="15" pos="179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han Rosemarie" initials="MR" lastIdx="3" clrIdx="0">
    <p:extLst>
      <p:ext uri="{19B8F6BF-5375-455C-9EA6-DF929625EA0E}">
        <p15:presenceInfo xmlns:p15="http://schemas.microsoft.com/office/powerpoint/2012/main" userId="S-1-5-21-2103329393-454622909-2920323692-138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Helle Formatvorlage 1 - Akz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2DE63D5-997A-4646-A377-4702673A728D}" styleName="Helle Formatvorlage 2 - Akz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8799B23B-EC83-4686-B30A-512413B5E67A}" styleName="Helle Formatvorlage 3 - Akz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8" autoAdjust="0"/>
    <p:restoredTop sz="94660"/>
  </p:normalViewPr>
  <p:slideViewPr>
    <p:cSldViewPr snapToGrid="0">
      <p:cViewPr varScale="1">
        <p:scale>
          <a:sx n="78" d="100"/>
          <a:sy n="78" d="100"/>
        </p:scale>
        <p:origin x="2335" y="75"/>
      </p:cViewPr>
      <p:guideLst>
        <p:guide orient="horz" pos="1248"/>
        <p:guide pos="618"/>
        <p:guide orient="horz" pos="2313"/>
        <p:guide pos="2976"/>
        <p:guide orient="horz" pos="5103"/>
        <p:guide orient="horz" pos="3447"/>
        <p:guide orient="horz" pos="3696"/>
        <p:guide orient="horz" pos="4344"/>
        <p:guide pos="4320"/>
        <p:guide orient="horz" pos="1383"/>
        <p:guide orient="horz" pos="744"/>
        <p:guide pos="179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098" y="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DDFBFE-B4EE-4111-8078-2730EF5F22F0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606" y="4776791"/>
            <a:ext cx="5438464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098" y="942975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A4A7BC-97C3-4583-8C69-B666DED6E3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81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Lena </a:t>
            </a:r>
            <a:r>
              <a:rPr lang="de-DE" dirty="0" err="1"/>
              <a:t>checked</a:t>
            </a:r>
            <a:r>
              <a:rPr lang="de-DE" dirty="0"/>
              <a:t> and </a:t>
            </a:r>
            <a:r>
              <a:rPr lang="de-DE"/>
              <a:t>updated</a:t>
            </a:r>
            <a:endParaRPr lang="en-US" dirty="0"/>
          </a:p>
          <a:p>
            <a:endParaRPr lang="en-US" dirty="0"/>
          </a:p>
          <a:p>
            <a:r>
              <a:rPr lang="en-US" dirty="0"/>
              <a:t>A and C    PART_1_HER2paper_EDI3inBCCLs</a:t>
            </a:r>
          </a:p>
          <a:p>
            <a:r>
              <a:rPr lang="de-DE" dirty="0"/>
              <a:t>\\storage.ifado.local\HepatoSys\Lena Zak\_</a:t>
            </a:r>
            <a:r>
              <a:rPr lang="de-DE" dirty="0" err="1"/>
              <a:t>for_Rosi</a:t>
            </a:r>
            <a:r>
              <a:rPr lang="de-DE" dirty="0"/>
              <a:t>\_Experiments\1_BCCLs_RNA&amp;PROTEIN</a:t>
            </a:r>
          </a:p>
          <a:p>
            <a:r>
              <a:rPr lang="de-DE" dirty="0"/>
              <a:t>\\storage.ifado.local\HepatoSys\Lena Zak\_</a:t>
            </a:r>
            <a:r>
              <a:rPr lang="de-DE" dirty="0" err="1"/>
              <a:t>for_Rosi</a:t>
            </a:r>
            <a:r>
              <a:rPr lang="de-DE" dirty="0"/>
              <a:t>\_Experiments\4_NMR</a:t>
            </a:r>
          </a:p>
          <a:p>
            <a:endParaRPr lang="de-DE" dirty="0"/>
          </a:p>
          <a:p>
            <a:r>
              <a:rPr lang="de-DE" dirty="0"/>
              <a:t>B  </a:t>
            </a:r>
            <a:r>
              <a:rPr lang="de-DE" baseline="0" dirty="0"/>
              <a:t>   </a:t>
            </a:r>
            <a:r>
              <a:rPr lang="de-DE" dirty="0"/>
              <a:t>\\storage.ifado.local\HepatoSys\Lena Zak\_</a:t>
            </a:r>
            <a:r>
              <a:rPr lang="de-DE" dirty="0" err="1"/>
              <a:t>for_Rosi</a:t>
            </a:r>
            <a:r>
              <a:rPr lang="de-DE" dirty="0"/>
              <a:t>\_Experiments\5_Staining</a:t>
            </a:r>
          </a:p>
          <a:p>
            <a:r>
              <a:rPr lang="de-DE" dirty="0"/>
              <a:t> </a:t>
            </a:r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B36AB5-9E1B-46A1-9F90-C6F0A0CBBE0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4771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Lena </a:t>
            </a:r>
            <a:r>
              <a:rPr lang="de-DE" dirty="0" err="1"/>
              <a:t>checked</a:t>
            </a:r>
            <a:r>
              <a:rPr lang="de-DE" dirty="0"/>
              <a:t> and </a:t>
            </a:r>
            <a:r>
              <a:rPr lang="de-DE" dirty="0" err="1"/>
              <a:t>updated</a:t>
            </a:r>
            <a:endParaRPr lang="de-DE" dirty="0"/>
          </a:p>
          <a:p>
            <a:endParaRPr lang="de-DE" dirty="0"/>
          </a:p>
          <a:p>
            <a:r>
              <a:rPr lang="de-DE" dirty="0"/>
              <a:t>A-B</a:t>
            </a:r>
            <a:r>
              <a:rPr lang="de-DE" baseline="0" dirty="0"/>
              <a:t>    </a:t>
            </a:r>
            <a:r>
              <a:rPr lang="en-US" dirty="0"/>
              <a:t>PART_2_HER2paper_HER2KD</a:t>
            </a:r>
          </a:p>
          <a:p>
            <a:r>
              <a:rPr lang="en-US" dirty="0"/>
              <a:t>\\storage.ifado.local\HepatoSys\Lena Zak\_</a:t>
            </a:r>
            <a:r>
              <a:rPr lang="en-US" dirty="0" err="1"/>
              <a:t>for_Rosi</a:t>
            </a:r>
            <a:r>
              <a:rPr lang="en-US" dirty="0"/>
              <a:t>\_Experiments\6_HER2 KD</a:t>
            </a:r>
          </a:p>
          <a:p>
            <a:endParaRPr lang="de-DE" dirty="0"/>
          </a:p>
          <a:p>
            <a:r>
              <a:rPr lang="de-DE" dirty="0"/>
              <a:t>C       PART_5_HER2project_BCCL's+Lap_Protein</a:t>
            </a:r>
          </a:p>
          <a:p>
            <a:r>
              <a:rPr lang="en-US" dirty="0"/>
              <a:t>\\storage.ifado.local\HepatoSys\Lena Zak\_</a:t>
            </a:r>
            <a:r>
              <a:rPr lang="en-US" dirty="0" err="1"/>
              <a:t>for_Rosi</a:t>
            </a:r>
            <a:r>
              <a:rPr lang="en-US" dirty="0"/>
              <a:t>\_Experiments\12_BCCLs +pathway inhibitors\BCCLs + Lapatinib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0C26B9-C0BA-468F-8EE7-7A8FB5D3313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030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855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204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889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081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574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974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563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1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422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906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348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325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png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2.png"/><Relationship Id="rId7" Type="http://schemas.openxmlformats.org/officeDocument/2006/relationships/image" Target="../media/image16.emf"/><Relationship Id="rId12" Type="http://schemas.openxmlformats.org/officeDocument/2006/relationships/image" Target="../media/image2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emf"/><Relationship Id="rId11" Type="http://schemas.openxmlformats.org/officeDocument/2006/relationships/image" Target="../media/image20.emf"/><Relationship Id="rId5" Type="http://schemas.openxmlformats.org/officeDocument/2006/relationships/image" Target="../media/image14.png"/><Relationship Id="rId10" Type="http://schemas.openxmlformats.org/officeDocument/2006/relationships/image" Target="../media/image19.emf"/><Relationship Id="rId4" Type="http://schemas.openxmlformats.org/officeDocument/2006/relationships/image" Target="../media/image13.png"/><Relationship Id="rId9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6" descr="Picture 6"/>
          <p:cNvPicPr>
            <a:picLocks noChangeAspect="1"/>
          </p:cNvPicPr>
          <p:nvPr/>
        </p:nvPicPr>
        <p:blipFill>
          <a:blip r:embed="rId3"/>
          <a:srcRect r="25164"/>
          <a:stretch>
            <a:fillRect/>
          </a:stretch>
        </p:blipFill>
        <p:spPr>
          <a:xfrm>
            <a:off x="4281374" y="2074828"/>
            <a:ext cx="2632142" cy="2325722"/>
          </a:xfrm>
          <a:prstGeom prst="rect">
            <a:avLst/>
          </a:prstGeom>
          <a:ln w="12700">
            <a:miter lim="400000"/>
          </a:ln>
        </p:spPr>
      </p:pic>
      <p:sp>
        <p:nvSpPr>
          <p:cNvPr id="8" name="TextBox 7"/>
          <p:cNvSpPr txBox="1"/>
          <p:nvPr/>
        </p:nvSpPr>
        <p:spPr>
          <a:xfrm>
            <a:off x="12283" y="225554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25209" y="19687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827251" y="225554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Rectangle 16"/>
          <p:cNvSpPr/>
          <p:nvPr/>
        </p:nvSpPr>
        <p:spPr>
          <a:xfrm>
            <a:off x="264528" y="151519"/>
            <a:ext cx="6345448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DI3 is highly expressed in ER-HER2+ cells and is regulated by HER2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left panel)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R2 mRNA expressi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easur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qRT-PCR. Quantificatio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right panel)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R protein expression from immunoblotting as represented in Fig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D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aining,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tabolite levels measured using NMR in a panel of breast cancer cell lines representing the different breast cancer subtype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ER2 and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DI3 mRNA,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ression in HCC1954 cells upon HER2 silencing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DI3 and HER2 mRNA expression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DI3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HER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 expression in SKBR3 cells after silencing EDI3 with siRNA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I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DI3 and HER2 mRNA expression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DI3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HER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 expression in HCC1954 cells after silencing EDI3 with siRNA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Western blots showing EDI3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pHER2 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HER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 expression in HCC1954 cells treated with 0.1 µM or 1.0 µM lapatinib for 24, 48, 72 an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6 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with corresponding quantification of protein levels.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ta are mean ± SD or mean ± SE for HER2 protein expression in panel A of at least three independent experiments (*,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 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1; *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01; **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001;  ns, not significant). </a:t>
            </a:r>
          </a:p>
        </p:txBody>
      </p:sp>
      <p:sp>
        <p:nvSpPr>
          <p:cNvPr id="21" name="TextBox 20"/>
          <p:cNvSpPr txBox="1"/>
          <p:nvPr/>
        </p:nvSpPr>
        <p:spPr>
          <a:xfrm flipH="1">
            <a:off x="453715" y="6787180"/>
            <a:ext cx="733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flipH="1">
            <a:off x="3420332" y="6809685"/>
            <a:ext cx="733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56634" y="45212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30087" y="7472438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CC1954</a:t>
            </a: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0523" y="7102611"/>
            <a:ext cx="1337931" cy="914400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="" xmlns:a16="http://schemas.microsoft.com/office/drawing/2014/main" id="{8B8D1200-152B-1EE7-10C4-ECCD34B8E98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569" y="2389007"/>
            <a:ext cx="1435100" cy="2082800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="" xmlns:a16="http://schemas.microsoft.com/office/drawing/2014/main" id="{A79950DB-D498-347C-A12F-D4E3DAE4CA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85507" y="2396363"/>
            <a:ext cx="1435100" cy="2082800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="" xmlns:a16="http://schemas.microsoft.com/office/drawing/2014/main" id="{14E1BEE3-B972-1D69-3F25-C154477E59F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57944" y="2377365"/>
            <a:ext cx="1422400" cy="2082800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="" xmlns:a16="http://schemas.microsoft.com/office/drawing/2014/main" id="{75CCDC14-2D34-246D-36BA-EC43AA29233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33050" y="4657725"/>
            <a:ext cx="1447800" cy="2082800"/>
          </a:xfrm>
          <a:prstGeom prst="rect">
            <a:avLst/>
          </a:prstGeom>
        </p:spPr>
      </p:pic>
      <p:pic>
        <p:nvPicPr>
          <p:cNvPr id="30" name="Grafik 29">
            <a:extLst>
              <a:ext uri="{FF2B5EF4-FFF2-40B4-BE49-F238E27FC236}">
                <a16:creationId xmlns="" xmlns:a16="http://schemas.microsoft.com/office/drawing/2014/main" id="{6F38328F-405B-5041-FBF1-906D1004300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26944" y="4656718"/>
            <a:ext cx="1422400" cy="2082800"/>
          </a:xfrm>
          <a:prstGeom prst="rect">
            <a:avLst/>
          </a:prstGeom>
        </p:spPr>
      </p:pic>
      <p:pic>
        <p:nvPicPr>
          <p:cNvPr id="32" name="Grafik 31">
            <a:extLst>
              <a:ext uri="{FF2B5EF4-FFF2-40B4-BE49-F238E27FC236}">
                <a16:creationId xmlns="" xmlns:a16="http://schemas.microsoft.com/office/drawing/2014/main" id="{4CA3151A-7E8F-D19A-6869-4E0C0C9C543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28204" y="4656718"/>
            <a:ext cx="1460500" cy="2082800"/>
          </a:xfrm>
          <a:prstGeom prst="rect">
            <a:avLst/>
          </a:prstGeom>
        </p:spPr>
      </p:pic>
      <p:pic>
        <p:nvPicPr>
          <p:cNvPr id="34" name="Grafik 33">
            <a:extLst>
              <a:ext uri="{FF2B5EF4-FFF2-40B4-BE49-F238E27FC236}">
                <a16:creationId xmlns="" xmlns:a16="http://schemas.microsoft.com/office/drawing/2014/main" id="{4DB500EE-0AE1-6CF6-7F2D-3DBA648CDC8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88529" y="6937154"/>
            <a:ext cx="1346200" cy="1651000"/>
          </a:xfrm>
          <a:prstGeom prst="rect">
            <a:avLst/>
          </a:prstGeom>
        </p:spPr>
      </p:pic>
      <p:pic>
        <p:nvPicPr>
          <p:cNvPr id="36" name="Grafik 35">
            <a:extLst>
              <a:ext uri="{FF2B5EF4-FFF2-40B4-BE49-F238E27FC236}">
                <a16:creationId xmlns="" xmlns:a16="http://schemas.microsoft.com/office/drawing/2014/main" id="{E7093211-BBF9-974F-B948-86CC8688A73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098322" y="6943344"/>
            <a:ext cx="1320800" cy="1638300"/>
          </a:xfrm>
          <a:prstGeom prst="rect">
            <a:avLst/>
          </a:prstGeom>
        </p:spPr>
      </p:pic>
      <p:pic>
        <p:nvPicPr>
          <p:cNvPr id="38" name="Grafik 37">
            <a:extLst>
              <a:ext uri="{FF2B5EF4-FFF2-40B4-BE49-F238E27FC236}">
                <a16:creationId xmlns="" xmlns:a16="http://schemas.microsoft.com/office/drawing/2014/main" id="{72170453-0AE0-C527-BA98-9F3D9E39196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909613" y="6938009"/>
            <a:ext cx="1320800" cy="165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8480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 flipH="1">
            <a:off x="644393" y="934537"/>
            <a:ext cx="541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flipH="1">
            <a:off x="2446690" y="934537"/>
            <a:ext cx="541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70563" y="1442792"/>
            <a:ext cx="752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KBR3</a:t>
            </a:r>
          </a:p>
        </p:txBody>
      </p:sp>
      <p:sp>
        <p:nvSpPr>
          <p:cNvPr id="28" name="TextBox 9">
            <a:extLst>
              <a:ext uri="{FF2B5EF4-FFF2-40B4-BE49-F238E27FC236}">
                <a16:creationId xmlns="" xmlns:a16="http://schemas.microsoft.com/office/drawing/2014/main" id="{125A216E-52AC-4242-BD35-C548F90C792B}"/>
              </a:ext>
            </a:extLst>
          </p:cNvPr>
          <p:cNvSpPr txBox="1"/>
          <p:nvPr/>
        </p:nvSpPr>
        <p:spPr>
          <a:xfrm flipH="1">
            <a:off x="644393" y="2695172"/>
            <a:ext cx="541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0">
            <a:extLst>
              <a:ext uri="{FF2B5EF4-FFF2-40B4-BE49-F238E27FC236}">
                <a16:creationId xmlns="" xmlns:a16="http://schemas.microsoft.com/office/drawing/2014/main" id="{90D7E71D-945E-4983-9C7B-180FDA0294B8}"/>
              </a:ext>
            </a:extLst>
          </p:cNvPr>
          <p:cNvSpPr txBox="1"/>
          <p:nvPr/>
        </p:nvSpPr>
        <p:spPr>
          <a:xfrm flipH="1">
            <a:off x="2446690" y="2695172"/>
            <a:ext cx="541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19">
            <a:extLst>
              <a:ext uri="{FF2B5EF4-FFF2-40B4-BE49-F238E27FC236}">
                <a16:creationId xmlns="" xmlns:a16="http://schemas.microsoft.com/office/drawing/2014/main" id="{3144097E-7DC7-4BFE-996C-A350FF27546E}"/>
              </a:ext>
            </a:extLst>
          </p:cNvPr>
          <p:cNvSpPr txBox="1"/>
          <p:nvPr/>
        </p:nvSpPr>
        <p:spPr>
          <a:xfrm rot="16200000">
            <a:off x="189149" y="3165259"/>
            <a:ext cx="9156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CC1954</a:t>
            </a:r>
          </a:p>
        </p:txBody>
      </p:sp>
      <p:sp>
        <p:nvSpPr>
          <p:cNvPr id="35" name="TextBox 34"/>
          <p:cNvSpPr txBox="1"/>
          <p:nvPr/>
        </p:nvSpPr>
        <p:spPr>
          <a:xfrm flipH="1">
            <a:off x="309047" y="4069180"/>
            <a:ext cx="733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77731" y="5398476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CC1954</a:t>
            </a:r>
          </a:p>
        </p:txBody>
      </p:sp>
      <p:sp>
        <p:nvSpPr>
          <p:cNvPr id="41" name="Rectangle 40"/>
          <p:cNvSpPr/>
          <p:nvPr/>
        </p:nvSpPr>
        <p:spPr>
          <a:xfrm>
            <a:off x="264528" y="151519"/>
            <a:ext cx="63454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1 cont´d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2368" y="4128692"/>
            <a:ext cx="6114271" cy="13716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80116" y="934537"/>
            <a:ext cx="1641600" cy="1055437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80846" y="2591223"/>
            <a:ext cx="1641600" cy="111677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="" xmlns:a16="http://schemas.microsoft.com/office/drawing/2014/main" id="{5F04825D-B3CC-D51A-B352-5A1DA549FF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5348" y="717901"/>
            <a:ext cx="1511300" cy="1739900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="" xmlns:a16="http://schemas.microsoft.com/office/drawing/2014/main" id="{9757FA67-B345-639F-E2BF-20DEE68259B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4279" y="2412014"/>
            <a:ext cx="1524000" cy="1739900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="" xmlns:a16="http://schemas.microsoft.com/office/drawing/2014/main" id="{B53CBD6A-16F9-C6E2-EF59-BB560879E66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76725" y="720380"/>
            <a:ext cx="1968500" cy="1739900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="" xmlns:a16="http://schemas.microsoft.com/office/drawing/2014/main" id="{1AF1190C-DCDF-C10F-2580-D6D54B044C8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73962" y="2413358"/>
            <a:ext cx="1968500" cy="1739900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="" xmlns:a16="http://schemas.microsoft.com/office/drawing/2014/main" id="{635FF0B7-9A3F-A956-BCB9-E43E4E4DD5E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44393" y="5585084"/>
            <a:ext cx="1892300" cy="1651000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="" xmlns:a16="http://schemas.microsoft.com/office/drawing/2014/main" id="{C851F7C7-72C7-BC14-09E9-BD28B9AFA52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09202" y="5592121"/>
            <a:ext cx="1892300" cy="1638300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="" xmlns:a16="http://schemas.microsoft.com/office/drawing/2014/main" id="{092A13AA-C4D6-AF2E-4349-8B340F07873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47450" y="5602060"/>
            <a:ext cx="1828800" cy="1638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8095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321</Words>
  <Application>Microsoft Office PowerPoint</Application>
  <PresentationFormat>On-screen Show (4:3)</PresentationFormat>
  <Paragraphs>3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olina Edlund</dc:creator>
  <cp:lastModifiedBy>Marchan Rosemarie</cp:lastModifiedBy>
  <cp:revision>313</cp:revision>
  <cp:lastPrinted>2022-12-07T13:08:46Z</cp:lastPrinted>
  <dcterms:created xsi:type="dcterms:W3CDTF">2020-02-28T15:51:27Z</dcterms:created>
  <dcterms:modified xsi:type="dcterms:W3CDTF">2023-01-06T12:00:17Z</dcterms:modified>
</cp:coreProperties>
</file>